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2" r:id="rId2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MS PGothic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MS PGothic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MS PGothic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MS PGothic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MS PGothic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MS PGothic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MS PGothic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MS PGothic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MS PGothic" pitchFamily="34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902" autoAdjust="0"/>
    <p:restoredTop sz="94660"/>
  </p:normalViewPr>
  <p:slideViewPr>
    <p:cSldViewPr snapToGrid="0">
      <p:cViewPr>
        <p:scale>
          <a:sx n="95" d="100"/>
          <a:sy n="95" d="100"/>
        </p:scale>
        <p:origin x="-1824" y="-330"/>
      </p:cViewPr>
      <p:guideLst>
        <p:guide orient="horz" pos="2160"/>
        <p:guide pos="5759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devinder.sandhu.USSL\Dropbox\Office\Papers%20new\Revertant%20Cloning\Submitted%20to%20PLOS%20ONE%2010.27.15\Expression%20maize%20Arabidopsis%20rice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C$82</c:f>
              <c:strCache>
                <c:ptCount val="1"/>
                <c:pt idx="0">
                  <c:v>FPKM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cat>
            <c:strRef>
              <c:f>Sheet1!$B$83:$B$88</c:f>
              <c:strCache>
                <c:ptCount val="6"/>
                <c:pt idx="0">
                  <c:v>Root</c:v>
                </c:pt>
                <c:pt idx="1">
                  <c:v>Stem</c:v>
                </c:pt>
                <c:pt idx="2">
                  <c:v>Leaves</c:v>
                </c:pt>
                <c:pt idx="3">
                  <c:v>Flower buds</c:v>
                </c:pt>
                <c:pt idx="4">
                  <c:v>Pod</c:v>
                </c:pt>
                <c:pt idx="5">
                  <c:v>Seed</c:v>
                </c:pt>
              </c:strCache>
            </c:strRef>
          </c:cat>
          <c:val>
            <c:numRef>
              <c:f>Sheet1!$C$83:$C$88</c:f>
              <c:numCache>
                <c:formatCode>General</c:formatCode>
                <c:ptCount val="6"/>
                <c:pt idx="0">
                  <c:v>0</c:v>
                </c:pt>
                <c:pt idx="1">
                  <c:v>1.7000000000000001E-2</c:v>
                </c:pt>
                <c:pt idx="2">
                  <c:v>6.0000000000000001E-3</c:v>
                </c:pt>
                <c:pt idx="3">
                  <c:v>2.5000000000000001E-2</c:v>
                </c:pt>
                <c:pt idx="4">
                  <c:v>2.1999999999999999E-2</c:v>
                </c:pt>
                <c:pt idx="5">
                  <c:v>1.6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68815744"/>
        <c:axId val="275552128"/>
      </c:barChart>
      <c:catAx>
        <c:axId val="26881574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 rot="-1500000"/>
          <a:lstStyle/>
          <a:p>
            <a:pPr>
              <a:defRPr sz="1200"/>
            </a:pPr>
            <a:endParaRPr lang="en-US"/>
          </a:p>
        </c:txPr>
        <c:crossAx val="275552128"/>
        <c:crosses val="autoZero"/>
        <c:auto val="1"/>
        <c:lblAlgn val="ctr"/>
        <c:lblOffset val="100"/>
        <c:tickLblSkip val="1"/>
        <c:noMultiLvlLbl val="0"/>
      </c:catAx>
      <c:valAx>
        <c:axId val="275552128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FPKM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6881574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4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C$3</c:f>
              <c:strCache>
                <c:ptCount val="1"/>
                <c:pt idx="0">
                  <c:v>FPKM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cat>
            <c:strRef>
              <c:f>Sheet1!$B$5:$B$9</c:f>
              <c:strCache>
                <c:ptCount val="5"/>
                <c:pt idx="0">
                  <c:v>Stems</c:v>
                </c:pt>
                <c:pt idx="1">
                  <c:v>Leaves</c:v>
                </c:pt>
                <c:pt idx="2">
                  <c:v>Immature tassel</c:v>
                </c:pt>
                <c:pt idx="3">
                  <c:v>Immature cob</c:v>
                </c:pt>
                <c:pt idx="4">
                  <c:v>Seed</c:v>
                </c:pt>
              </c:strCache>
            </c:strRef>
          </c:cat>
          <c:val>
            <c:numRef>
              <c:f>Sheet1!$C$5:$C$9</c:f>
              <c:numCache>
                <c:formatCode>General</c:formatCode>
                <c:ptCount val="5"/>
                <c:pt idx="0">
                  <c:v>10.1</c:v>
                </c:pt>
                <c:pt idx="1">
                  <c:v>0.4</c:v>
                </c:pt>
                <c:pt idx="2">
                  <c:v>7.3</c:v>
                </c:pt>
                <c:pt idx="3">
                  <c:v>18.5</c:v>
                </c:pt>
                <c:pt idx="4">
                  <c:v>6.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81010560"/>
        <c:axId val="281012480"/>
      </c:barChart>
      <c:catAx>
        <c:axId val="281010560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 rot="-1500000"/>
          <a:lstStyle/>
          <a:p>
            <a:pPr>
              <a:defRPr sz="1200"/>
            </a:pPr>
            <a:endParaRPr lang="en-US"/>
          </a:p>
        </c:txPr>
        <c:crossAx val="281012480"/>
        <c:crosses val="autoZero"/>
        <c:auto val="1"/>
        <c:lblAlgn val="ctr"/>
        <c:lblOffset val="100"/>
        <c:noMultiLvlLbl val="0"/>
      </c:catAx>
      <c:valAx>
        <c:axId val="281012480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FPKM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8101056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4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C$29</c:f>
              <c:strCache>
                <c:ptCount val="1"/>
                <c:pt idx="0">
                  <c:v>FPKM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cat>
            <c:strRef>
              <c:f>Sheet1!$B$30:$B$33</c:f>
              <c:strCache>
                <c:ptCount val="4"/>
                <c:pt idx="0">
                  <c:v>Root</c:v>
                </c:pt>
                <c:pt idx="1">
                  <c:v>Shoot</c:v>
                </c:pt>
                <c:pt idx="2">
                  <c:v>Leaves</c:v>
                </c:pt>
                <c:pt idx="3">
                  <c:v>Flower buds</c:v>
                </c:pt>
              </c:strCache>
            </c:strRef>
          </c:cat>
          <c:val>
            <c:numRef>
              <c:f>Sheet1!$C$30:$C$33</c:f>
              <c:numCache>
                <c:formatCode>General</c:formatCode>
                <c:ptCount val="4"/>
                <c:pt idx="0">
                  <c:v>0.6</c:v>
                </c:pt>
                <c:pt idx="1">
                  <c:v>0.2</c:v>
                </c:pt>
                <c:pt idx="2">
                  <c:v>0.6</c:v>
                </c:pt>
                <c:pt idx="3">
                  <c:v>0.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89133696"/>
        <c:axId val="289135232"/>
      </c:barChart>
      <c:catAx>
        <c:axId val="289133696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 rot="-1500000"/>
          <a:lstStyle/>
          <a:p>
            <a:pPr>
              <a:defRPr sz="1200"/>
            </a:pPr>
            <a:endParaRPr lang="en-US"/>
          </a:p>
        </c:txPr>
        <c:crossAx val="289135232"/>
        <c:crosses val="autoZero"/>
        <c:auto val="1"/>
        <c:lblAlgn val="ctr"/>
        <c:lblOffset val="100"/>
        <c:noMultiLvlLbl val="0"/>
      </c:catAx>
      <c:valAx>
        <c:axId val="289135232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FPKM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8913369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4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cat>
            <c:strRef>
              <c:f>Sheet1!$B$54:$B$59</c:f>
              <c:strCache>
                <c:ptCount val="6"/>
                <c:pt idx="0">
                  <c:v>Shoot</c:v>
                </c:pt>
                <c:pt idx="1">
                  <c:v>Leaves</c:v>
                </c:pt>
                <c:pt idx="2">
                  <c:v>Anther</c:v>
                </c:pt>
                <c:pt idx="3">
                  <c:v>Pistil</c:v>
                </c:pt>
                <c:pt idx="4">
                  <c:v>Inflorescence</c:v>
                </c:pt>
                <c:pt idx="5">
                  <c:v>Seed</c:v>
                </c:pt>
              </c:strCache>
            </c:strRef>
          </c:cat>
          <c:val>
            <c:numRef>
              <c:f>Sheet1!$C$54:$C$59</c:f>
              <c:numCache>
                <c:formatCode>General</c:formatCode>
                <c:ptCount val="6"/>
                <c:pt idx="0">
                  <c:v>0</c:v>
                </c:pt>
                <c:pt idx="1">
                  <c:v>0.34006500000000001</c:v>
                </c:pt>
                <c:pt idx="2">
                  <c:v>0.66561999999999999</c:v>
                </c:pt>
                <c:pt idx="3">
                  <c:v>0.58046399999999998</c:v>
                </c:pt>
                <c:pt idx="4">
                  <c:v>1.3010600000000001</c:v>
                </c:pt>
                <c:pt idx="5">
                  <c:v>0.184152000000000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90578816"/>
        <c:axId val="290580352"/>
      </c:barChart>
      <c:catAx>
        <c:axId val="290578816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 rot="-1500000"/>
          <a:lstStyle/>
          <a:p>
            <a:pPr>
              <a:defRPr sz="1200"/>
            </a:pPr>
            <a:endParaRPr lang="en-US"/>
          </a:p>
        </c:txPr>
        <c:crossAx val="290580352"/>
        <c:crosses val="autoZero"/>
        <c:auto val="1"/>
        <c:lblAlgn val="ctr"/>
        <c:lblOffset val="100"/>
        <c:noMultiLvlLbl val="0"/>
      </c:catAx>
      <c:valAx>
        <c:axId val="290580352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FPKM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9057881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4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2AD1E7C-173D-4C54-A492-DCF39E681DEB}" type="datetimeFigureOut">
              <a:rPr lang="en-US" altLang="en-US"/>
              <a:pPr>
                <a:defRPr/>
              </a:pPr>
              <a:t>1/20/2016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604673B-817B-4D15-9999-9A0D0D93BBA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8357327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09A3E03-7573-443E-BB56-1D9D19D5AA83}" type="datetimeFigureOut">
              <a:rPr lang="en-US" altLang="en-US"/>
              <a:pPr>
                <a:defRPr/>
              </a:pPr>
              <a:t>1/20/2016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7B1800B-F9E9-4AF8-97E6-AB16918440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025657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9891044-7152-490C-B4D7-59AA2785A9F4}" type="datetimeFigureOut">
              <a:rPr lang="en-US" altLang="en-US"/>
              <a:pPr>
                <a:defRPr/>
              </a:pPr>
              <a:t>1/20/2016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7840E04-F40C-408B-A52F-90A22196AED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752110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920EA83-7ACD-4F41-955C-334272CAFA5C}" type="datetimeFigureOut">
              <a:rPr lang="en-US" altLang="en-US"/>
              <a:pPr>
                <a:defRPr/>
              </a:pPr>
              <a:t>1/20/2016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E6AAAE7-468C-40B0-9469-B61D82483238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1299016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4586CBA-94D9-48D6-BD13-F7171D058965}" type="datetimeFigureOut">
              <a:rPr lang="en-US" altLang="en-US"/>
              <a:pPr>
                <a:defRPr/>
              </a:pPr>
              <a:t>1/20/2016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F37B5AA-8F52-4ED7-BA1D-968AA7A72356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2173147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9F89093-A9B5-4248-9C00-C3A412761E8C}" type="datetimeFigureOut">
              <a:rPr lang="en-US" altLang="en-US"/>
              <a:pPr>
                <a:defRPr/>
              </a:pPr>
              <a:t>1/20/2016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2FBE9C-BE92-4582-A980-7574E310427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4600269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0CA4D87-E08C-44EB-940B-4BCBF802E195}" type="datetimeFigureOut">
              <a:rPr lang="en-US" altLang="en-US"/>
              <a:pPr>
                <a:defRPr/>
              </a:pPr>
              <a:t>1/20/2016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195A264-BC37-4CDB-B354-3D251E2C6D13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721425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4E9DA60-86AD-43C7-AC73-F0D2C9AAD5EB}" type="datetimeFigureOut">
              <a:rPr lang="en-US" altLang="en-US"/>
              <a:pPr>
                <a:defRPr/>
              </a:pPr>
              <a:t>1/20/2016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5384B80-27B2-460D-B3DF-5BC11CC247C2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1087013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6379E4A-BBCE-4D70-B4C3-CDC220999FA1}" type="datetimeFigureOut">
              <a:rPr lang="en-US" altLang="en-US"/>
              <a:pPr>
                <a:defRPr/>
              </a:pPr>
              <a:t>1/20/2016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06EA14B-DEE7-4B1D-A254-96BC0FF6D46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3694326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C65399D-7E1B-42B9-867A-AE2F594690F3}" type="datetimeFigureOut">
              <a:rPr lang="en-US" altLang="en-US"/>
              <a:pPr>
                <a:defRPr/>
              </a:pPr>
              <a:t>1/20/2016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7A3A4A0-4CA8-4824-86BA-9F723E76F89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162865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F7F09FB-7166-4AEB-AC5A-E56352791858}" type="datetimeFigureOut">
              <a:rPr lang="en-US" altLang="en-US"/>
              <a:pPr>
                <a:defRPr/>
              </a:pPr>
              <a:t>1/20/2016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DF55A34-0722-4D36-9B45-1693B7AC477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7176936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F242974B-1994-42DA-BCAE-6C355ABD00A1}" type="datetimeFigureOut">
              <a:rPr lang="en-US" altLang="en-US"/>
              <a:pPr>
                <a:defRPr/>
              </a:pPr>
              <a:t>1/20/2016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B40CBB3B-F53F-4167-82FF-EF64EBCBECB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MS PGothic" pitchFamily="34" charset="-128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hyperlink" Target="#_ENREF_28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hyperlink" Target="#_ENREF_23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0" name="Chart 1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3664493"/>
              </p:ext>
            </p:extLst>
          </p:nvPr>
        </p:nvGraphicFramePr>
        <p:xfrm>
          <a:off x="2163723" y="25400"/>
          <a:ext cx="4480560" cy="16459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62600167"/>
              </p:ext>
            </p:extLst>
          </p:nvPr>
        </p:nvGraphicFramePr>
        <p:xfrm>
          <a:off x="2163723" y="4384140"/>
          <a:ext cx="4480560" cy="16459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71824704"/>
              </p:ext>
            </p:extLst>
          </p:nvPr>
        </p:nvGraphicFramePr>
        <p:xfrm>
          <a:off x="2163723" y="1499214"/>
          <a:ext cx="4480560" cy="16459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52962728"/>
              </p:ext>
            </p:extLst>
          </p:nvPr>
        </p:nvGraphicFramePr>
        <p:xfrm>
          <a:off x="2163723" y="2911624"/>
          <a:ext cx="4480560" cy="16459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793510" y="148852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793510" y="3013728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)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793510" y="1599634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835060" y="4491607"/>
            <a:ext cx="19415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ize (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RMZM2G346278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2869564" y="3104493"/>
            <a:ext cx="19698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ice (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OC_OS02G40450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2869564" y="1655849"/>
            <a:ext cx="18299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rabidopsis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T3G27730)</a:t>
            </a:r>
            <a:endParaRPr lang="en-US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2955824" y="124655"/>
            <a:ext cx="22493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oybean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8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yma.16G072300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1793510" y="4495125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0" y="6012083"/>
            <a:ext cx="9153525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 eaLnBrk="0" hangingPunct="0"/>
            <a:r>
              <a:rPr lang="en-US" sz="1200" b="1" dirty="0" smtClean="0"/>
              <a:t>S3 </a:t>
            </a:r>
            <a:r>
              <a:rPr lang="en-US" sz="1200" b="1" dirty="0"/>
              <a:t>Fig</a:t>
            </a:r>
            <a:r>
              <a:rPr lang="en-US" sz="1200" b="1" dirty="0" smtClean="0"/>
              <a:t>. </a:t>
            </a:r>
            <a:r>
              <a:rPr lang="en-US" altLang="en-US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Expression </a:t>
            </a:r>
            <a:r>
              <a:rPr lang="en-US" altLang="en-US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analyses of soybean </a:t>
            </a:r>
            <a:r>
              <a:rPr lang="en-US" altLang="en-US" sz="1200" i="1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st8</a:t>
            </a:r>
            <a:r>
              <a:rPr lang="en-US" altLang="en-US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and its homologs in Arabidopsis, rice and maize. A) RNA-</a:t>
            </a:r>
            <a:r>
              <a:rPr lang="en-US" altLang="en-US" sz="1200" dirty="0" err="1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seq</a:t>
            </a:r>
            <a:r>
              <a:rPr lang="en-US" altLang="en-US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analysis of </a:t>
            </a:r>
            <a:r>
              <a:rPr lang="en-US" altLang="en-US" sz="1200" i="1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st8</a:t>
            </a:r>
            <a:r>
              <a:rPr lang="en-US" altLang="en-US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(</a:t>
            </a:r>
            <a:r>
              <a:rPr lang="en-US" altLang="en-US" sz="1200" i="1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Glyma.16G07230)</a:t>
            </a:r>
            <a:r>
              <a:rPr lang="en-US" altLang="en-US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in different soybean tissues. B) RNA-</a:t>
            </a:r>
            <a:r>
              <a:rPr lang="en-US" altLang="en-US" sz="1200" dirty="0" err="1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seq</a:t>
            </a:r>
            <a:r>
              <a:rPr lang="en-US" altLang="en-US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analysis of MER3 homolog, </a:t>
            </a:r>
            <a:r>
              <a:rPr lang="en-US" altLang="en-US" sz="1200" i="1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AT3G27730</a:t>
            </a:r>
            <a:r>
              <a:rPr lang="en-US" altLang="en-US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, in different Arabidopsis tissues. C) RNA-</a:t>
            </a:r>
            <a:r>
              <a:rPr lang="en-US" altLang="en-US" sz="1200" dirty="0" err="1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seq</a:t>
            </a:r>
            <a:r>
              <a:rPr lang="en-US" altLang="en-US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analysis of MER3 homolog, </a:t>
            </a:r>
            <a:r>
              <a:rPr lang="en-US" altLang="en-US" sz="1200" i="1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LOC_OS02G40450</a:t>
            </a:r>
            <a:r>
              <a:rPr lang="en-US" altLang="en-US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, in different rice tissues.  D) RNA-</a:t>
            </a:r>
            <a:r>
              <a:rPr lang="en-US" altLang="en-US" sz="1200" dirty="0" err="1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seq</a:t>
            </a:r>
            <a:r>
              <a:rPr lang="en-US" altLang="en-US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analysis of MER3 homolog, </a:t>
            </a:r>
            <a:r>
              <a:rPr lang="en-US" altLang="en-US" sz="1200" i="1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GRMZM2G346278</a:t>
            </a:r>
            <a:r>
              <a:rPr lang="en-US" altLang="en-US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, in different maize tissues. FPKM, Fragments Per </a:t>
            </a:r>
            <a:r>
              <a:rPr lang="en-US" altLang="en-US" sz="1200" dirty="0" err="1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Kilobase</a:t>
            </a:r>
            <a:r>
              <a:rPr lang="en-US" altLang="en-US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of transcript per Million mapped reads [</a:t>
            </a:r>
            <a:r>
              <a:rPr lang="en-US" altLang="en-US" sz="1200" dirty="0">
                <a:latin typeface="Times New Roman" pitchFamily="18" charset="0"/>
                <a:ea typeface="Calibri" pitchFamily="34" charset="0"/>
                <a:cs typeface="Times New Roman" pitchFamily="18" charset="0"/>
                <a:hlinkClick r:id="rId6" tooltip="Severin, 2010 #67"/>
              </a:rPr>
              <a:t>23</a:t>
            </a:r>
            <a:r>
              <a:rPr lang="en-US" altLang="en-US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, </a:t>
            </a:r>
            <a:r>
              <a:rPr lang="en-US" altLang="en-US" sz="1200" dirty="0">
                <a:latin typeface="Times New Roman" pitchFamily="18" charset="0"/>
                <a:ea typeface="Calibri" pitchFamily="34" charset="0"/>
                <a:cs typeface="Times New Roman" pitchFamily="18" charset="0"/>
                <a:hlinkClick r:id="rId7" tooltip="Sekhon, 2013 #74"/>
              </a:rPr>
              <a:t>28-30</a:t>
            </a:r>
            <a:r>
              <a:rPr lang="en-US" altLang="en-US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].</a:t>
            </a:r>
            <a:endParaRPr lang="en-US" alt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499027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0052</TotalTime>
  <Words>122</Words>
  <Application>Microsoft Office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Iowa State University Department of Agronom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umbach, Jordan L [AGRON]</dc:creator>
  <cp:lastModifiedBy>Devinder Sandhu</cp:lastModifiedBy>
  <cp:revision>117</cp:revision>
  <dcterms:created xsi:type="dcterms:W3CDTF">2013-06-12T21:49:42Z</dcterms:created>
  <dcterms:modified xsi:type="dcterms:W3CDTF">2016-01-20T17:39:03Z</dcterms:modified>
</cp:coreProperties>
</file>